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3" d="100"/>
          <a:sy n="113" d="100"/>
        </p:scale>
        <p:origin x="31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042620A-FF88-3FFF-F0EF-0C17B8C3BF5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0DD48D99-3455-EF63-FC30-FDE0ABDBE99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3F67AFC-BF16-3A69-11B5-ADA262B4C7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DAEB1-ED03-4441-955E-29FC245533A3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393E24B-8940-B171-2EA4-E8320073D5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7CEE758-E879-5B37-CE38-39D6DC2D38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57627C-5FFE-49F9-9782-5E4F300731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28753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4F8FC6E-7963-90D3-AACF-95CEBBE756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29853A8-FE28-D51A-9316-56BD281E98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7624DCD-06EC-BC38-0924-76616194EE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DAEB1-ED03-4441-955E-29FC245533A3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9A5E007-46F4-C4B2-5BBD-C28F576A81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310A03D-FB2C-B9C3-8E48-94BB20ED7B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57627C-5FFE-49F9-9782-5E4F300731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54509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3DD29221-D610-6FA2-9501-9FD18DEDF2F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7E30AF4-8077-5145-A868-26253A269B6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CDACBF6-CBFE-E39D-3F84-4B8B9F01E5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DAEB1-ED03-4441-955E-29FC245533A3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6E9D5FE-BE76-7107-F558-A7285B2903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42976F1-4EB8-1F69-7872-8F53C1DE09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57627C-5FFE-49F9-9782-5E4F300731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56711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F8825D4-280C-019F-ADE0-E3DFF35840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0ACDACE-9514-EBB1-9D10-1E8472DFEF8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DA91E6E-A6A0-CBD7-D2ED-D5C02C0B58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DAEB1-ED03-4441-955E-29FC245533A3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5E2BCB4-5FF9-695C-2BE7-F1B95C8B5B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4CD1BE8-14F1-30DB-EB05-4F74764D68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57627C-5FFE-49F9-9782-5E4F300731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22027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5105510-6667-DA50-7937-C6EE423E39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AAB18E3-B55A-E0D2-3590-BB5FE8B4D7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52270DF-4B0D-10FD-FE9F-28C0BE0187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DAEB1-ED03-4441-955E-29FC245533A3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2AE6BF5-859F-64E2-5AF7-ADE93E83AB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6A1DF62-C8C5-223C-F394-807C0660BB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57627C-5FFE-49F9-9782-5E4F300731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63925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401C81B-A847-7CE9-374E-EF1942FC07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0DA5135-3459-845D-EFC1-2AEBE381C58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D55B7C2-0752-2FA5-A0F0-9C769E48485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A4CB415-7933-C33F-4F0F-DF6B9ABA11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DAEB1-ED03-4441-955E-29FC245533A3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C09AAC6-5FE3-116F-C2EF-12B7FB028D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A55B855-A747-C6CF-7EB8-476CB7EFB0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57627C-5FFE-49F9-9782-5E4F300731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11164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40E11C2-6795-89BA-5B1C-B381BE9794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68CDB27-87C2-4FB5-8714-E85617F32C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D70A249-37B2-4B4D-9C4B-0A21B78E42B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000869E4-52BE-01D9-5B9A-215DE9B4AFE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AB2782A0-862D-4EDB-8112-F817EF3B0EF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3D9F7214-302B-3A29-CC85-40BC2987D6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DAEB1-ED03-4441-955E-29FC245533A3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7EA6479-2A30-8071-1B50-79F8694FB3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0D6E45D2-A2C9-2D7C-B988-6D6A54E2DD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57627C-5FFE-49F9-9782-5E4F300731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51368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48C8F08-E75D-3530-E1D3-54EF6D3A42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B36E18B-C7DA-BDEE-7381-9B6F8429E8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DAEB1-ED03-4441-955E-29FC245533A3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59D539EC-60AC-4633-096A-CAE2933285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D55F30C-B6E5-3D9E-A95D-A5CB1D28AD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57627C-5FFE-49F9-9782-5E4F300731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38137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B62E51A2-ABAA-EE19-FB82-07D2765EBA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DAEB1-ED03-4441-955E-29FC245533A3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93AE84BA-E297-6116-450A-583E7CCBF3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0C2E6531-7925-44C5-E851-654AB3ACAD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57627C-5FFE-49F9-9782-5E4F300731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94032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DD26AC1-6BF4-7EAE-5695-EBBC97BF71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F700889-0212-DBE5-1E9C-C6D5C3205C7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2436C45-89FA-F285-37DF-89721FE9D4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0603E31-3BEA-F827-75F2-797D86025E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DAEB1-ED03-4441-955E-29FC245533A3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0DB44AA-8755-AD6F-184F-B68A42AD29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8C4191B-AC48-0A76-F688-BD2378ABCA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57627C-5FFE-49F9-9782-5E4F300731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98026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452B896-FBAE-B8A1-5F7E-6FAA2EC985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482CDDC0-4EE6-21F4-475A-4959ECF1FE9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BFDC19E-D807-47B5-037F-2CF28D709BD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56E6E1D-4A96-928E-C585-F75F624181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DAEB1-ED03-4441-955E-29FC245533A3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C678CC6-29AA-E34A-4936-CB45714375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85E0AA6-7E18-9C62-478F-F1B7815CEC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57627C-5FFE-49F9-9782-5E4F300731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35884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F6B2C08B-506E-3ABA-26B1-4C010243F0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7103E2A-280A-92DD-B795-704E53C838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3DF83DC-3A98-0A76-A101-536C8355B9E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EDAEB1-ED03-4441-955E-29FC245533A3}" type="datetimeFigureOut">
              <a:rPr lang="zh-CN" altLang="en-US" smtClean="0"/>
              <a:t>2024/6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4EB9EB9-1E81-A7B9-46B9-BBDEBABA464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EA9C6C8-ED29-CC28-22F0-370ACA4CEE9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57627C-5FFE-49F9-9782-5E4F300731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54253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6E620F71-3B50-1A7A-7934-ADFC52F3988B}"/>
              </a:ext>
            </a:extLst>
          </p:cNvPr>
          <p:cNvSpPr txBox="1"/>
          <p:nvPr/>
        </p:nvSpPr>
        <p:spPr>
          <a:xfrm>
            <a:off x="2566168" y="5664956"/>
            <a:ext cx="7602297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400" b="1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Supplementary Figure 5. Omics associated load diagram</a:t>
            </a:r>
            <a:r>
              <a:rPr lang="en-US" altLang="zh-CN" sz="1400" b="1">
                <a:latin typeface="Times New Roman" panose="02020603050405020304" pitchFamily="18" charset="0"/>
                <a:ea typeface="宋体" panose="02010600030101010101" pitchFamily="2" charset="-122"/>
              </a:rPr>
              <a:t>.</a:t>
            </a:r>
            <a:r>
              <a:rPr lang="zh-CN" altLang="en-US" sz="1400" b="1"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r>
              <a:rPr lang="en-US" altLang="zh-CN" sz="140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Each dot represents a gene or a metabolite. The horizontal coordinate is the first one-dimensional coordinate of the joint part, and the vertical coordinate is the second two-dimensional coordinate of the joint part. The greater the absolute value of an element in its coordinates, the greater the degree of association that element has with another omics.</a:t>
            </a:r>
            <a:endParaRPr lang="zh-CN" altLang="en-US" sz="1400"/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69E784D8-B306-3970-FA39-11BD6660BA8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5031" y="238937"/>
            <a:ext cx="6041293" cy="51782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24504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70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靖欣 霍</dc:creator>
  <cp:lastModifiedBy>靖欣 霍</cp:lastModifiedBy>
  <cp:revision>1</cp:revision>
  <dcterms:created xsi:type="dcterms:W3CDTF">2024-06-28T06:57:26Z</dcterms:created>
  <dcterms:modified xsi:type="dcterms:W3CDTF">2024-06-28T07:02:56Z</dcterms:modified>
</cp:coreProperties>
</file>